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88" r:id="rId2"/>
  </p:sldIdLst>
  <p:sldSz cx="16916400" cy="21945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1320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z, Alexander" userId="302c93c3-6320-4d3c-a68d-a1fdc247d2f3" providerId="ADAL" clId="{D45CCC64-8761-44AD-97AB-AAB488A74BB8}"/>
    <pc:docChg chg="modSld">
      <pc:chgData name="Franz, Alexander" userId="302c93c3-6320-4d3c-a68d-a1fdc247d2f3" providerId="ADAL" clId="{D45CCC64-8761-44AD-97AB-AAB488A74BB8}" dt="2025-06-16T20:17:05.952" v="3" actId="122"/>
      <pc:docMkLst>
        <pc:docMk/>
      </pc:docMkLst>
      <pc:sldChg chg="modSp mod">
        <pc:chgData name="Franz, Alexander" userId="302c93c3-6320-4d3c-a68d-a1fdc247d2f3" providerId="ADAL" clId="{D45CCC64-8761-44AD-97AB-AAB488A74BB8}" dt="2025-06-16T20:17:05.952" v="3" actId="122"/>
        <pc:sldMkLst>
          <pc:docMk/>
          <pc:sldMk cId="342682865" sldId="288"/>
        </pc:sldMkLst>
        <pc:graphicFrameChg chg="modGraphic">
          <ac:chgData name="Franz, Alexander" userId="302c93c3-6320-4d3c-a68d-a1fdc247d2f3" providerId="ADAL" clId="{D45CCC64-8761-44AD-97AB-AAB488A74BB8}" dt="2025-06-16T20:17:05.952" v="3" actId="122"/>
          <ac:graphicFrameMkLst>
            <pc:docMk/>
            <pc:sldMk cId="342682865" sldId="288"/>
            <ac:graphicFrameMk id="3" creationId="{6DB7EEBF-42A6-6810-D535-33BC20EC441A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2EB3E9-7FC1-4091-982A-3ED580D49C5A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143000"/>
            <a:ext cx="2378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D2B3F1-9DE9-4B62-87EA-66A776D0C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6059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1pPr>
    <a:lvl2pPr marL="563179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2pPr>
    <a:lvl3pPr marL="1126358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3pPr>
    <a:lvl4pPr marL="1689537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4pPr>
    <a:lvl5pPr marL="2252716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5pPr>
    <a:lvl6pPr marL="2815895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6pPr>
    <a:lvl7pPr marL="3379074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7pPr>
    <a:lvl8pPr marL="3942253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8pPr>
    <a:lvl9pPr marL="4505432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68730" y="3591562"/>
            <a:ext cx="14378940" cy="7640320"/>
          </a:xfrm>
        </p:spPr>
        <p:txBody>
          <a:bodyPr anchor="b"/>
          <a:lstStyle>
            <a:lvl1pPr algn="ctr">
              <a:defRPr sz="11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14550" y="11526522"/>
            <a:ext cx="12687300" cy="5298438"/>
          </a:xfrm>
        </p:spPr>
        <p:txBody>
          <a:bodyPr/>
          <a:lstStyle>
            <a:lvl1pPr marL="0" indent="0" algn="ctr">
              <a:buNone/>
              <a:defRPr sz="4440"/>
            </a:lvl1pPr>
            <a:lvl2pPr marL="845820" indent="0" algn="ctr">
              <a:buNone/>
              <a:defRPr sz="3700"/>
            </a:lvl2pPr>
            <a:lvl3pPr marL="1691640" indent="0" algn="ctr">
              <a:buNone/>
              <a:defRPr sz="3330"/>
            </a:lvl3pPr>
            <a:lvl4pPr marL="2537460" indent="0" algn="ctr">
              <a:buNone/>
              <a:defRPr sz="2960"/>
            </a:lvl4pPr>
            <a:lvl5pPr marL="3383280" indent="0" algn="ctr">
              <a:buNone/>
              <a:defRPr sz="2960"/>
            </a:lvl5pPr>
            <a:lvl6pPr marL="4229100" indent="0" algn="ctr">
              <a:buNone/>
              <a:defRPr sz="2960"/>
            </a:lvl6pPr>
            <a:lvl7pPr marL="5074920" indent="0" algn="ctr">
              <a:buNone/>
              <a:defRPr sz="2960"/>
            </a:lvl7pPr>
            <a:lvl8pPr marL="5920740" indent="0" algn="ctr">
              <a:buNone/>
              <a:defRPr sz="2960"/>
            </a:lvl8pPr>
            <a:lvl9pPr marL="6766560" indent="0" algn="ctr">
              <a:buNone/>
              <a:defRPr sz="2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464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626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105800" y="1168400"/>
            <a:ext cx="3647599" cy="1859788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63004" y="1168400"/>
            <a:ext cx="10731341" cy="1859788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074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658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193" y="5471167"/>
            <a:ext cx="14590395" cy="9128758"/>
          </a:xfrm>
        </p:spPr>
        <p:txBody>
          <a:bodyPr anchor="b"/>
          <a:lstStyle>
            <a:lvl1pPr>
              <a:defRPr sz="11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193" y="14686287"/>
            <a:ext cx="14590395" cy="4800598"/>
          </a:xfrm>
        </p:spPr>
        <p:txBody>
          <a:bodyPr/>
          <a:lstStyle>
            <a:lvl1pPr marL="0" indent="0">
              <a:buNone/>
              <a:defRPr sz="4440">
                <a:solidFill>
                  <a:schemeClr val="tx1">
                    <a:tint val="82000"/>
                  </a:schemeClr>
                </a:solidFill>
              </a:defRPr>
            </a:lvl1pPr>
            <a:lvl2pPr marL="845820" indent="0">
              <a:buNone/>
              <a:defRPr sz="3700">
                <a:solidFill>
                  <a:schemeClr val="tx1">
                    <a:tint val="82000"/>
                  </a:schemeClr>
                </a:solidFill>
              </a:defRPr>
            </a:lvl2pPr>
            <a:lvl3pPr marL="1691640" indent="0">
              <a:buNone/>
              <a:defRPr sz="3330">
                <a:solidFill>
                  <a:schemeClr val="tx1">
                    <a:tint val="82000"/>
                  </a:schemeClr>
                </a:solidFill>
              </a:defRPr>
            </a:lvl3pPr>
            <a:lvl4pPr marL="253746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4pPr>
            <a:lvl5pPr marL="338328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5pPr>
            <a:lvl6pPr marL="422910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6pPr>
            <a:lvl7pPr marL="507492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7pPr>
            <a:lvl8pPr marL="592074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8pPr>
            <a:lvl9pPr marL="676656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913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63003" y="5842000"/>
            <a:ext cx="718947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563928" y="5842000"/>
            <a:ext cx="718947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628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168405"/>
            <a:ext cx="14590395" cy="42418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5208" y="5379722"/>
            <a:ext cx="7156429" cy="2636518"/>
          </a:xfrm>
        </p:spPr>
        <p:txBody>
          <a:bodyPr anchor="b"/>
          <a:lstStyle>
            <a:lvl1pPr marL="0" indent="0">
              <a:buNone/>
              <a:defRPr sz="4440" b="1"/>
            </a:lvl1pPr>
            <a:lvl2pPr marL="845820" indent="0">
              <a:buNone/>
              <a:defRPr sz="3700" b="1"/>
            </a:lvl2pPr>
            <a:lvl3pPr marL="1691640" indent="0">
              <a:buNone/>
              <a:defRPr sz="3330" b="1"/>
            </a:lvl3pPr>
            <a:lvl4pPr marL="2537460" indent="0">
              <a:buNone/>
              <a:defRPr sz="2960" b="1"/>
            </a:lvl4pPr>
            <a:lvl5pPr marL="3383280" indent="0">
              <a:buNone/>
              <a:defRPr sz="2960" b="1"/>
            </a:lvl5pPr>
            <a:lvl6pPr marL="4229100" indent="0">
              <a:buNone/>
              <a:defRPr sz="2960" b="1"/>
            </a:lvl6pPr>
            <a:lvl7pPr marL="5074920" indent="0">
              <a:buNone/>
              <a:defRPr sz="2960" b="1"/>
            </a:lvl7pPr>
            <a:lvl8pPr marL="5920740" indent="0">
              <a:buNone/>
              <a:defRPr sz="2960" b="1"/>
            </a:lvl8pPr>
            <a:lvl9pPr marL="6766560" indent="0">
              <a:buNone/>
              <a:defRPr sz="2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65208" y="8016240"/>
            <a:ext cx="7156429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563929" y="5379722"/>
            <a:ext cx="7191673" cy="2636518"/>
          </a:xfrm>
        </p:spPr>
        <p:txBody>
          <a:bodyPr anchor="b"/>
          <a:lstStyle>
            <a:lvl1pPr marL="0" indent="0">
              <a:buNone/>
              <a:defRPr sz="4440" b="1"/>
            </a:lvl1pPr>
            <a:lvl2pPr marL="845820" indent="0">
              <a:buNone/>
              <a:defRPr sz="3700" b="1"/>
            </a:lvl2pPr>
            <a:lvl3pPr marL="1691640" indent="0">
              <a:buNone/>
              <a:defRPr sz="3330" b="1"/>
            </a:lvl3pPr>
            <a:lvl4pPr marL="2537460" indent="0">
              <a:buNone/>
              <a:defRPr sz="2960" b="1"/>
            </a:lvl4pPr>
            <a:lvl5pPr marL="3383280" indent="0">
              <a:buNone/>
              <a:defRPr sz="2960" b="1"/>
            </a:lvl5pPr>
            <a:lvl6pPr marL="4229100" indent="0">
              <a:buNone/>
              <a:defRPr sz="2960" b="1"/>
            </a:lvl6pPr>
            <a:lvl7pPr marL="5074920" indent="0">
              <a:buNone/>
              <a:defRPr sz="2960" b="1"/>
            </a:lvl7pPr>
            <a:lvl8pPr marL="5920740" indent="0">
              <a:buNone/>
              <a:defRPr sz="2960" b="1"/>
            </a:lvl8pPr>
            <a:lvl9pPr marL="6766560" indent="0">
              <a:buNone/>
              <a:defRPr sz="2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563929" y="8016240"/>
            <a:ext cx="7191673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912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334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907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463040"/>
            <a:ext cx="5455979" cy="5120640"/>
          </a:xfrm>
        </p:spPr>
        <p:txBody>
          <a:bodyPr anchor="b"/>
          <a:lstStyle>
            <a:lvl1pPr>
              <a:defRPr sz="5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1673" y="3159765"/>
            <a:ext cx="8563928" cy="15595600"/>
          </a:xfrm>
        </p:spPr>
        <p:txBody>
          <a:bodyPr/>
          <a:lstStyle>
            <a:lvl1pPr>
              <a:defRPr sz="5920"/>
            </a:lvl1pPr>
            <a:lvl2pPr>
              <a:defRPr sz="5180"/>
            </a:lvl2pPr>
            <a:lvl3pPr>
              <a:defRPr sz="4440"/>
            </a:lvl3pPr>
            <a:lvl4pPr>
              <a:defRPr sz="3700"/>
            </a:lvl4pPr>
            <a:lvl5pPr>
              <a:defRPr sz="3700"/>
            </a:lvl5pPr>
            <a:lvl6pPr>
              <a:defRPr sz="3700"/>
            </a:lvl6pPr>
            <a:lvl7pPr>
              <a:defRPr sz="3700"/>
            </a:lvl7pPr>
            <a:lvl8pPr>
              <a:defRPr sz="3700"/>
            </a:lvl8pPr>
            <a:lvl9pPr>
              <a:defRPr sz="3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5206" y="6583680"/>
            <a:ext cx="5455979" cy="12197082"/>
          </a:xfrm>
        </p:spPr>
        <p:txBody>
          <a:bodyPr/>
          <a:lstStyle>
            <a:lvl1pPr marL="0" indent="0">
              <a:buNone/>
              <a:defRPr sz="2960"/>
            </a:lvl1pPr>
            <a:lvl2pPr marL="845820" indent="0">
              <a:buNone/>
              <a:defRPr sz="2590"/>
            </a:lvl2pPr>
            <a:lvl3pPr marL="1691640" indent="0">
              <a:buNone/>
              <a:defRPr sz="2220"/>
            </a:lvl3pPr>
            <a:lvl4pPr marL="2537460" indent="0">
              <a:buNone/>
              <a:defRPr sz="1850"/>
            </a:lvl4pPr>
            <a:lvl5pPr marL="3383280" indent="0">
              <a:buNone/>
              <a:defRPr sz="1850"/>
            </a:lvl5pPr>
            <a:lvl6pPr marL="4229100" indent="0">
              <a:buNone/>
              <a:defRPr sz="1850"/>
            </a:lvl6pPr>
            <a:lvl7pPr marL="5074920" indent="0">
              <a:buNone/>
              <a:defRPr sz="1850"/>
            </a:lvl7pPr>
            <a:lvl8pPr marL="5920740" indent="0">
              <a:buNone/>
              <a:defRPr sz="1850"/>
            </a:lvl8pPr>
            <a:lvl9pPr marL="6766560" indent="0">
              <a:buNone/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72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463040"/>
            <a:ext cx="5455979" cy="5120640"/>
          </a:xfrm>
        </p:spPr>
        <p:txBody>
          <a:bodyPr anchor="b"/>
          <a:lstStyle>
            <a:lvl1pPr>
              <a:defRPr sz="5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191673" y="3159765"/>
            <a:ext cx="8563928" cy="15595600"/>
          </a:xfrm>
        </p:spPr>
        <p:txBody>
          <a:bodyPr anchor="t"/>
          <a:lstStyle>
            <a:lvl1pPr marL="0" indent="0">
              <a:buNone/>
              <a:defRPr sz="5920"/>
            </a:lvl1pPr>
            <a:lvl2pPr marL="845820" indent="0">
              <a:buNone/>
              <a:defRPr sz="5180"/>
            </a:lvl2pPr>
            <a:lvl3pPr marL="1691640" indent="0">
              <a:buNone/>
              <a:defRPr sz="4440"/>
            </a:lvl3pPr>
            <a:lvl4pPr marL="2537460" indent="0">
              <a:buNone/>
              <a:defRPr sz="3700"/>
            </a:lvl4pPr>
            <a:lvl5pPr marL="3383280" indent="0">
              <a:buNone/>
              <a:defRPr sz="3700"/>
            </a:lvl5pPr>
            <a:lvl6pPr marL="4229100" indent="0">
              <a:buNone/>
              <a:defRPr sz="3700"/>
            </a:lvl6pPr>
            <a:lvl7pPr marL="5074920" indent="0">
              <a:buNone/>
              <a:defRPr sz="3700"/>
            </a:lvl7pPr>
            <a:lvl8pPr marL="5920740" indent="0">
              <a:buNone/>
              <a:defRPr sz="3700"/>
            </a:lvl8pPr>
            <a:lvl9pPr marL="6766560" indent="0">
              <a:buNone/>
              <a:defRPr sz="3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5206" y="6583680"/>
            <a:ext cx="5455979" cy="12197082"/>
          </a:xfrm>
        </p:spPr>
        <p:txBody>
          <a:bodyPr/>
          <a:lstStyle>
            <a:lvl1pPr marL="0" indent="0">
              <a:buNone/>
              <a:defRPr sz="2960"/>
            </a:lvl1pPr>
            <a:lvl2pPr marL="845820" indent="0">
              <a:buNone/>
              <a:defRPr sz="2590"/>
            </a:lvl2pPr>
            <a:lvl3pPr marL="1691640" indent="0">
              <a:buNone/>
              <a:defRPr sz="2220"/>
            </a:lvl3pPr>
            <a:lvl4pPr marL="2537460" indent="0">
              <a:buNone/>
              <a:defRPr sz="1850"/>
            </a:lvl4pPr>
            <a:lvl5pPr marL="3383280" indent="0">
              <a:buNone/>
              <a:defRPr sz="1850"/>
            </a:lvl5pPr>
            <a:lvl6pPr marL="4229100" indent="0">
              <a:buNone/>
              <a:defRPr sz="1850"/>
            </a:lvl6pPr>
            <a:lvl7pPr marL="5074920" indent="0">
              <a:buNone/>
              <a:defRPr sz="1850"/>
            </a:lvl7pPr>
            <a:lvl8pPr marL="5920740" indent="0">
              <a:buNone/>
              <a:defRPr sz="1850"/>
            </a:lvl8pPr>
            <a:lvl9pPr marL="6766560" indent="0">
              <a:buNone/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234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63003" y="1168405"/>
            <a:ext cx="14590395" cy="4241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3003" y="5842000"/>
            <a:ext cx="14590395" cy="13924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63003" y="20340325"/>
            <a:ext cx="380619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603558" y="20340325"/>
            <a:ext cx="5709285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947208" y="20340325"/>
            <a:ext cx="380619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359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91640" rtl="0" eaLnBrk="1" latinLnBrk="0" hangingPunct="1">
        <a:lnSpc>
          <a:spcPct val="90000"/>
        </a:lnSpc>
        <a:spcBef>
          <a:spcPct val="0"/>
        </a:spcBef>
        <a:buNone/>
        <a:defRPr sz="81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2910" indent="-422910" algn="l" defTabSz="1691640" rtl="0" eaLnBrk="1" latinLnBrk="0" hangingPunct="1">
        <a:lnSpc>
          <a:spcPct val="90000"/>
        </a:lnSpc>
        <a:spcBef>
          <a:spcPts val="1850"/>
        </a:spcBef>
        <a:buFont typeface="Arial" panose="020B0604020202020204" pitchFamily="34" charset="0"/>
        <a:buChar char="•"/>
        <a:defRPr sz="5180" kern="1200">
          <a:solidFill>
            <a:schemeClr val="tx1"/>
          </a:solidFill>
          <a:latin typeface="+mn-lt"/>
          <a:ea typeface="+mn-ea"/>
          <a:cs typeface="+mn-cs"/>
        </a:defRPr>
      </a:lvl1pPr>
      <a:lvl2pPr marL="126873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4440" kern="1200">
          <a:solidFill>
            <a:schemeClr val="tx1"/>
          </a:solidFill>
          <a:latin typeface="+mn-lt"/>
          <a:ea typeface="+mn-ea"/>
          <a:cs typeface="+mn-cs"/>
        </a:defRPr>
      </a:lvl2pPr>
      <a:lvl3pPr marL="211455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3pPr>
      <a:lvl4pPr marL="296037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4pPr>
      <a:lvl5pPr marL="380619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5pPr>
      <a:lvl6pPr marL="465201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6pPr>
      <a:lvl7pPr marL="549783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7pPr>
      <a:lvl8pPr marL="634365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8pPr>
      <a:lvl9pPr marL="718947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1pPr>
      <a:lvl2pPr marL="84582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2pPr>
      <a:lvl3pPr marL="169164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3pPr>
      <a:lvl4pPr marL="253746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4pPr>
      <a:lvl5pPr marL="338328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5pPr>
      <a:lvl6pPr marL="422910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6pPr>
      <a:lvl7pPr marL="507492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7pPr>
      <a:lvl8pPr marL="592074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8pPr>
      <a:lvl9pPr marL="676656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A9DE237-DF9A-A31D-E674-EA5C41A8C5E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4C0BFE-38BF-65BF-9A13-BC18FE3F8BF6}"/>
              </a:ext>
            </a:extLst>
          </p:cNvPr>
          <p:cNvSpPr txBox="1">
            <a:spLocks/>
          </p:cNvSpPr>
          <p:nvPr/>
        </p:nvSpPr>
        <p:spPr>
          <a:xfrm>
            <a:off x="950284" y="1567419"/>
            <a:ext cx="13563157" cy="835540"/>
          </a:xfrm>
          <a:prstGeom prst="rect">
            <a:avLst/>
          </a:prstGeom>
        </p:spPr>
        <p:txBody>
          <a:bodyPr/>
          <a:lstStyle>
            <a:lvl1pPr algn="l" defTabSz="16916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81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200" b="1" dirty="0">
                <a:latin typeface="+mn-lt"/>
              </a:rPr>
              <a:t>S5 Table. </a:t>
            </a:r>
            <a:r>
              <a:rPr lang="en-US" sz="3200" dirty="0">
                <a:latin typeface="+mn-lt"/>
              </a:rPr>
              <a:t>Life history parameters used for gene drive modeling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6DB7EEBF-42A6-6810-D535-33BC20EC441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31165673"/>
              </p:ext>
            </p:extLst>
          </p:nvPr>
        </p:nvGraphicFramePr>
        <p:xfrm>
          <a:off x="1063256" y="2539502"/>
          <a:ext cx="13099312" cy="3220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860158">
                  <a:extLst>
                    <a:ext uri="{9D8B030D-6E8A-4147-A177-3AD203B41FA5}">
                      <a16:colId xmlns:a16="http://schemas.microsoft.com/office/drawing/2014/main" val="585285239"/>
                    </a:ext>
                  </a:extLst>
                </a:gridCol>
                <a:gridCol w="4646428">
                  <a:extLst>
                    <a:ext uri="{9D8B030D-6E8A-4147-A177-3AD203B41FA5}">
                      <a16:colId xmlns:a16="http://schemas.microsoft.com/office/drawing/2014/main" val="549341258"/>
                    </a:ext>
                  </a:extLst>
                </a:gridCol>
                <a:gridCol w="2828260">
                  <a:extLst>
                    <a:ext uri="{9D8B030D-6E8A-4147-A177-3AD203B41FA5}">
                      <a16:colId xmlns:a16="http://schemas.microsoft.com/office/drawing/2014/main" val="1929918535"/>
                    </a:ext>
                  </a:extLst>
                </a:gridCol>
                <a:gridCol w="2764466">
                  <a:extLst>
                    <a:ext uri="{9D8B030D-6E8A-4147-A177-3AD203B41FA5}">
                      <a16:colId xmlns:a16="http://schemas.microsoft.com/office/drawing/2014/main" val="374938195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800" dirty="0" err="1">
                          <a:solidFill>
                            <a:sysClr val="windowText" lastClr="000000"/>
                          </a:solidFill>
                        </a:rPr>
                        <a:t>MGDrivE</a:t>
                      </a:r>
                      <a:r>
                        <a:rPr lang="en-US" sz="1800" dirty="0">
                          <a:solidFill>
                            <a:sysClr val="windowText" lastClr="000000"/>
                          </a:solidFill>
                        </a:rPr>
                        <a:t> paramet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solidFill>
                            <a:sysClr val="windowText" lastClr="000000"/>
                          </a:solidFill>
                        </a:rPr>
                        <a:t>Descrip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solidFill>
                            <a:sysClr val="windowText" lastClr="000000"/>
                          </a:solidFill>
                        </a:rPr>
                        <a:t>Stochastic simulation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solidFill>
                            <a:sysClr val="windowText" lastClr="000000"/>
                          </a:solidFill>
                        </a:rPr>
                        <a:t>Non-overlapping simulation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56189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dirty="0" err="1"/>
                        <a:t>betaK</a:t>
                      </a:r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Daily egg production rate of adult femal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2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6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46221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dirty="0" err="1"/>
                        <a:t>tEgg</a:t>
                      </a:r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#days in egg stag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46633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dirty="0" err="1"/>
                        <a:t>tlarva</a:t>
                      </a:r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# days in larval stag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111933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dirty="0" err="1"/>
                        <a:t>tpupa</a:t>
                      </a:r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# days in pupal stag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8910780"/>
                  </a:ext>
                </a:extLst>
              </a:tr>
              <a:tr h="354330">
                <a:tc>
                  <a:txBody>
                    <a:bodyPr/>
                    <a:lstStyle/>
                    <a:p>
                      <a:r>
                        <a:rPr lang="en-US" sz="1800" dirty="0" err="1"/>
                        <a:t>popgrowth</a:t>
                      </a:r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Population growth rat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1.17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1.000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2880691"/>
                  </a:ext>
                </a:extLst>
              </a:tr>
              <a:tr h="354330">
                <a:tc>
                  <a:txBody>
                    <a:bodyPr/>
                    <a:lstStyle/>
                    <a:p>
                      <a:r>
                        <a:rPr lang="en-US" sz="1800" dirty="0" err="1"/>
                        <a:t>muAd</a:t>
                      </a:r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Daily mortality rate of adult mosquito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0.0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0.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2226634"/>
                  </a:ext>
                </a:extLst>
              </a:tr>
              <a:tr h="354330">
                <a:tc>
                  <a:txBody>
                    <a:bodyPr/>
                    <a:lstStyle/>
                    <a:p>
                      <a:r>
                        <a:rPr lang="en-US" sz="1800" dirty="0" err="1"/>
                        <a:t>adultPopEquilibrium</a:t>
                      </a:r>
                      <a:endParaRPr 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/>
                        <a:t>Equilibrium state effective population siz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50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1000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4722078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FC668067-D52D-44D1-B3FA-00EB10A8C08B}"/>
              </a:ext>
            </a:extLst>
          </p:cNvPr>
          <p:cNvSpPr txBox="1"/>
          <p:nvPr/>
        </p:nvSpPr>
        <p:spPr>
          <a:xfrm>
            <a:off x="1063255" y="5962650"/>
            <a:ext cx="1309931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For the stochastic models, parameters were set to match the life history traits for </a:t>
            </a:r>
            <a:r>
              <a:rPr lang="en-US" sz="2400" i="1" dirty="0"/>
              <a:t>Ae. aegypti</a:t>
            </a:r>
            <a:r>
              <a:rPr lang="en-US" sz="2400" dirty="0"/>
              <a:t>. The life history parameters for the non-overlapping simulations were adjusted </a:t>
            </a:r>
            <a:r>
              <a:rPr lang="en-US" sz="2400" i="1" dirty="0"/>
              <a:t>ad hoc </a:t>
            </a:r>
            <a:r>
              <a:rPr lang="en-US" sz="2400" dirty="0"/>
              <a:t>to produce a quasi-discrete, non-overlapping generation population structure. 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B3328D4-D71B-CA2C-69BE-AC6C9B416ADC}"/>
              </a:ext>
            </a:extLst>
          </p:cNvPr>
          <p:cNvSpPr txBox="1"/>
          <p:nvPr/>
        </p:nvSpPr>
        <p:spPr>
          <a:xfrm>
            <a:off x="1063254" y="7896642"/>
            <a:ext cx="13563157" cy="43396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buNone/>
            </a:pPr>
            <a:r>
              <a:rPr lang="en-US" sz="2000" b="1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References </a:t>
            </a:r>
          </a:p>
          <a:p>
            <a:pPr marL="0" marR="0">
              <a:buNone/>
            </a:pPr>
            <a:endParaRPr lang="en-US" sz="2000" b="1" dirty="0">
              <a:solidFill>
                <a:srgbClr val="000000"/>
              </a:solidFill>
              <a:effectLst/>
              <a:ea typeface="Times New Roman" panose="02020603050405020304" pitchFamily="18" charset="0"/>
              <a:cs typeface="Aptos" panose="020B0004020202020204" pitchFamily="34" charset="0"/>
            </a:endParaRPr>
          </a:p>
          <a:p>
            <a:pPr marL="342900" marR="0" indent="-342900">
              <a:buFont typeface="+mj-lt"/>
              <a:buAutoNum type="arabicPeriod"/>
            </a:pPr>
            <a:r>
              <a:rPr lang="en-US" sz="2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Otero M, Solari HG, </a:t>
            </a:r>
            <a:r>
              <a:rPr lang="en-US" sz="20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Schweigmann</a:t>
            </a:r>
            <a:r>
              <a:rPr lang="en-US" sz="2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 N.2006. A stochastic population dynamics model for </a:t>
            </a:r>
            <a:r>
              <a:rPr lang="en-US" sz="2000" i="1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Aedes aegypti</a:t>
            </a:r>
            <a:r>
              <a:rPr lang="en-US" sz="2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: formulation and application to a city with temperate climate. Bull Math Biol. 68(8):1945-1974. </a:t>
            </a:r>
            <a:endParaRPr lang="en-US" sz="2000" dirty="0">
              <a:effectLst/>
              <a:ea typeface="Aptos" panose="020B0004020202020204" pitchFamily="34" charset="0"/>
              <a:cs typeface="Aptos" panose="020B0004020202020204" pitchFamily="34" charset="0"/>
            </a:endParaRPr>
          </a:p>
          <a:p>
            <a:pPr marL="342900" marR="0" indent="-342900">
              <a:buFont typeface="+mj-lt"/>
              <a:buAutoNum type="arabicPeriod"/>
            </a:pPr>
            <a:r>
              <a:rPr lang="en-US" sz="2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Christophers SR. 1960. </a:t>
            </a:r>
            <a:r>
              <a:rPr lang="en-US" sz="2000" i="1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Aedes aegypti: </a:t>
            </a:r>
            <a:r>
              <a:rPr lang="en-US" sz="2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the yellow fever mosquito. 1st ed., Cambridge University Press, London, UK. </a:t>
            </a:r>
            <a:endParaRPr lang="en-US" sz="2000" dirty="0">
              <a:effectLst/>
              <a:ea typeface="Aptos" panose="020B0004020202020204" pitchFamily="34" charset="0"/>
              <a:cs typeface="Aptos" panose="020B0004020202020204" pitchFamily="34" charset="0"/>
            </a:endParaRPr>
          </a:p>
          <a:p>
            <a:pPr marL="342900" marR="0" indent="-342900">
              <a:buFont typeface="+mj-lt"/>
              <a:buAutoNum type="arabicPeriod"/>
            </a:pPr>
            <a:r>
              <a:rPr lang="en-US" sz="20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Simoy</a:t>
            </a:r>
            <a:r>
              <a:rPr lang="en-US" sz="2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 MI, </a:t>
            </a:r>
            <a:r>
              <a:rPr lang="en-US" sz="20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Simoy</a:t>
            </a:r>
            <a:r>
              <a:rPr lang="en-US" sz="2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 MV, Canziani GA. 2015. The effect of temperature on the population dynamics of </a:t>
            </a:r>
            <a:r>
              <a:rPr lang="en-US" sz="2000" i="1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Aedes aegypti</a:t>
            </a:r>
            <a:r>
              <a:rPr lang="en-US" sz="2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. Ecological modeling 314:100-110.6. </a:t>
            </a:r>
            <a:endParaRPr lang="en-US" sz="2000" dirty="0">
              <a:effectLst/>
              <a:ea typeface="Aptos" panose="020B0004020202020204" pitchFamily="34" charset="0"/>
              <a:cs typeface="Aptos" panose="020B0004020202020204" pitchFamily="34" charset="0"/>
            </a:endParaRPr>
          </a:p>
          <a:p>
            <a:pPr marL="342900" marR="0" indent="-342900">
              <a:buFont typeface="+mj-lt"/>
              <a:buAutoNum type="arabicPeriod"/>
            </a:pPr>
            <a:r>
              <a:rPr lang="en-US" sz="2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Fay, R. W. 1964. The biology and bionomics of </a:t>
            </a:r>
            <a:r>
              <a:rPr lang="en-US" sz="2000" i="1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Aedes aegypti </a:t>
            </a:r>
            <a:r>
              <a:rPr lang="en-US" sz="2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in the laboratory. </a:t>
            </a:r>
            <a:r>
              <a:rPr lang="en-US" sz="2000" i="1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Mosquito News </a:t>
            </a:r>
            <a:r>
              <a:rPr lang="en-US" sz="2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24(3):300-308. </a:t>
            </a:r>
            <a:endParaRPr lang="en-US" sz="2000" dirty="0">
              <a:effectLst/>
              <a:ea typeface="Aptos" panose="020B0004020202020204" pitchFamily="34" charset="0"/>
              <a:cs typeface="Aptos" panose="020B0004020202020204" pitchFamily="34" charset="0"/>
            </a:endParaRPr>
          </a:p>
          <a:p>
            <a:pPr marL="342900" marR="0" indent="-342900">
              <a:buFont typeface="+mj-lt"/>
              <a:buAutoNum type="arabicPeriod"/>
            </a:pPr>
            <a:r>
              <a:rPr lang="en-US" sz="2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Focks DA, Haile DG, Daniels E, Mount GA. 1993. Dynamic life table model for </a:t>
            </a:r>
            <a:r>
              <a:rPr lang="en-US" sz="2000" i="1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Aedes aegypti </a:t>
            </a:r>
            <a:r>
              <a:rPr lang="en-US" sz="2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(Diptera: Culicidae): Analysis of the literature and model development. J Med </a:t>
            </a:r>
            <a:r>
              <a:rPr lang="en-US" sz="20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Entomol</a:t>
            </a:r>
            <a:r>
              <a:rPr lang="en-US" sz="2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. 30(6):1003-1017. </a:t>
            </a:r>
            <a:endParaRPr lang="en-US" sz="2000" dirty="0">
              <a:effectLst/>
              <a:ea typeface="Aptos" panose="020B0004020202020204" pitchFamily="34" charset="0"/>
              <a:cs typeface="Aptos" panose="020B0004020202020204" pitchFamily="34" charset="0"/>
            </a:endParaRPr>
          </a:p>
          <a:p>
            <a:pPr marL="342900" marR="0" indent="-342900">
              <a:buFont typeface="+mj-lt"/>
              <a:buAutoNum type="arabicPeriod"/>
            </a:pPr>
            <a:r>
              <a:rPr lang="en-US" sz="2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ptos" panose="020B0004020202020204" pitchFamily="34" charset="0"/>
              </a:rPr>
              <a:t>Horsfall WR. 1955. M</a:t>
            </a:r>
            <a:r>
              <a:rPr lang="en-US" sz="2000" i="0" dirty="0">
                <a:effectLst/>
              </a:rPr>
              <a:t>osquitoes: Their Bionomics and Relation to Disease. William R. Horsfall. Ronald Press, New York, 1955. viii + 723 pp</a:t>
            </a:r>
            <a:r>
              <a:rPr lang="en-US" sz="2000" i="0" dirty="0">
                <a:solidFill>
                  <a:srgbClr val="474747"/>
                </a:solidFill>
                <a:effectLst/>
              </a:rPr>
              <a:t>. </a:t>
            </a:r>
            <a:endParaRPr lang="en-US" sz="2000" dirty="0">
              <a:effectLst/>
              <a:ea typeface="Aptos" panose="020B0004020202020204" pitchFamily="34" charset="0"/>
              <a:cs typeface="Aptos" panose="020B0004020202020204" pitchFamily="34" charset="0"/>
            </a:endParaRPr>
          </a:p>
          <a:p>
            <a:pPr marL="0" marR="0">
              <a:buNone/>
            </a:pPr>
            <a:r>
              <a:rPr lang="en-US" sz="1800" dirty="0">
                <a:solidFill>
                  <a:srgbClr val="000000"/>
                </a:solidFill>
                <a:effectLst/>
                <a:latin typeface="Aptos" panose="020B0004020202020204" pitchFamily="34" charset="0"/>
                <a:ea typeface="Times New Roman" panose="02020603050405020304" pitchFamily="18" charset="0"/>
                <a:cs typeface="Aptos" panose="020B0004020202020204" pitchFamily="34" charset="0"/>
              </a:rPr>
              <a:t> </a:t>
            </a:r>
            <a:endParaRPr lang="en-US" sz="1800" dirty="0">
              <a:effectLst/>
              <a:latin typeface="Aptos" panose="020B0004020202020204" pitchFamily="34" charset="0"/>
              <a:ea typeface="Aptos" panose="020B0004020202020204" pitchFamily="34" charset="0"/>
              <a:cs typeface="Aptos" panose="020B0004020202020204" pitchFamily="34" charset="0"/>
            </a:endParaRPr>
          </a:p>
          <a:p>
            <a:pPr marL="0" marR="0"/>
            <a:r>
              <a:rPr lang="en-US" sz="1800" dirty="0">
                <a:solidFill>
                  <a:srgbClr val="000000"/>
                </a:solidFill>
                <a:effectLst/>
                <a:latin typeface="Aptos" panose="020B0004020202020204" pitchFamily="34" charset="0"/>
                <a:ea typeface="Times New Roman" panose="02020603050405020304" pitchFamily="18" charset="0"/>
                <a:cs typeface="Aptos" panose="020B0004020202020204" pitchFamily="34" charset="0"/>
              </a:rPr>
              <a:t> </a:t>
            </a:r>
            <a:endParaRPr lang="en-US" sz="1800" dirty="0">
              <a:effectLst/>
              <a:latin typeface="Aptos" panose="020B0004020202020204" pitchFamily="34" charset="0"/>
              <a:ea typeface="Aptos" panose="020B0004020202020204" pitchFamily="34" charset="0"/>
              <a:cs typeface="Aptos" panose="020B00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6828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462</TotalTime>
  <Words>307</Words>
  <Application>Microsoft Office PowerPoint</Application>
  <PresentationFormat>Custom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ach Speth</dc:creator>
  <cp:lastModifiedBy>Franz, Alexander</cp:lastModifiedBy>
  <cp:revision>432</cp:revision>
  <dcterms:created xsi:type="dcterms:W3CDTF">2024-06-26T16:03:17Z</dcterms:created>
  <dcterms:modified xsi:type="dcterms:W3CDTF">2025-06-16T20:17:38Z</dcterms:modified>
</cp:coreProperties>
</file>